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4" r:id="rId3"/>
    <p:sldId id="257" r:id="rId4"/>
    <p:sldId id="265" r:id="rId5"/>
    <p:sldId id="259" r:id="rId6"/>
    <p:sldId id="260" r:id="rId7"/>
    <p:sldId id="261" r:id="rId8"/>
    <p:sldId id="266" r:id="rId9"/>
    <p:sldId id="262" r:id="rId10"/>
    <p:sldId id="263" r:id="rId11"/>
    <p:sldId id="267" r:id="rId12"/>
    <p:sldId id="268" r:id="rId13"/>
    <p:sldId id="269" r:id="rId14"/>
    <p:sldId id="270" r:id="rId1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284" y="-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Case I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User\Dropbox\Publications\thalamic\Case 2\59688475-Frame1.jpg2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33600" y="990600"/>
            <a:ext cx="4876800" cy="48768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C:\Users\User\Dropbox\Publications\thalamic\Case 2\59688511-Frame1.jpg2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33600" y="990600"/>
            <a:ext cx="4876800" cy="48768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 descr="C:\Users\User\Dropbox\Publications\thalamic\Case 2\59688547-Frame1.jpg2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33600" y="990600"/>
            <a:ext cx="4876800" cy="48768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 descr="C:\Users\User\Dropbox\Publications\thalamic\Case 2\CT 2 enlarged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654300" y="1381125"/>
            <a:ext cx="3835400" cy="409575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 descr="C:\Users\User\Dropbox\Publications\thalamic\Case 2\case 2 CT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81200" y="152400"/>
            <a:ext cx="4586720" cy="585216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User\Dropbox\Publications\thalamic\Case 1\case 1 CT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28888" y="928688"/>
            <a:ext cx="4086225" cy="5000625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User\Dropbox\Publications\thalamic\Case 1\CT 1 enlarged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24000" y="711200"/>
            <a:ext cx="6096000" cy="54356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Case II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User\Dropbox\Publications\thalamic\Case 2\59686821-Frame1.jpg2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33600" y="990600"/>
            <a:ext cx="4876800" cy="48768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User\Dropbox\Publications\thalamic\Case 2\59686857-Frame1.jpg2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33600" y="990600"/>
            <a:ext cx="4876800" cy="48768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User\Dropbox\Publications\thalamic\Case 2\59686875-Frame1.jpg2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33600" y="990600"/>
            <a:ext cx="4876800" cy="48768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C:\Users\User\Dropbox\Publications\thalamic\Case 2\59686893-Frame1.jpg2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33600" y="990600"/>
            <a:ext cx="4876800" cy="48768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C:\Users\User\Dropbox\Publications\thalamic\Case 2\59688403-Frame1.jpg2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33600" y="990600"/>
            <a:ext cx="4876800" cy="48768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4</Words>
  <Application>Microsoft Office PowerPoint</Application>
  <PresentationFormat>On-screen Show (4:3)</PresentationFormat>
  <Paragraphs>2</Paragraphs>
  <Slides>1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5" baseType="lpstr">
      <vt:lpstr>Office Theme</vt:lpstr>
      <vt:lpstr>Case I</vt:lpstr>
      <vt:lpstr>Slide 2</vt:lpstr>
      <vt:lpstr>Slide 3</vt:lpstr>
      <vt:lpstr>Case II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se I</dc:title>
  <dc:creator>Guwani Liyanage</dc:creator>
  <cp:lastModifiedBy>Guwani Liyanage</cp:lastModifiedBy>
  <cp:revision>1</cp:revision>
  <dcterms:created xsi:type="dcterms:W3CDTF">2006-08-16T00:00:00Z</dcterms:created>
  <dcterms:modified xsi:type="dcterms:W3CDTF">2016-06-11T05:32:10Z</dcterms:modified>
</cp:coreProperties>
</file>